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59" r:id="rId2"/>
    <p:sldId id="256" r:id="rId3"/>
    <p:sldId id="257" r:id="rId4"/>
    <p:sldId id="258" r:id="rId5"/>
    <p:sldId id="260" r:id="rId6"/>
    <p:sldId id="261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3"/>
  </p:normalViewPr>
  <p:slideViewPr>
    <p:cSldViewPr snapToGrid="0" snapToObjects="1">
      <p:cViewPr varScale="1">
        <p:scale>
          <a:sx n="93" d="100"/>
          <a:sy n="93" d="100"/>
        </p:scale>
        <p:origin x="286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BD8B97-EF08-0D45-8327-123230F11727}" type="datetimeFigureOut">
              <a:rPr lang="en-US" smtClean="0"/>
              <a:t>6/1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1DF35B-F707-144F-A500-9A277638E6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361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1DF35B-F707-144F-A500-9A277638E66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1769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1DF35B-F707-144F-A500-9A277638E66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7331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964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986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419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735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051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307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131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614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707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171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265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988E5-58B4-464D-803D-4FA3924EFD24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BCD4D-F205-2E46-A224-AB025F6B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100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ti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7771ABE-9284-9B4F-84DB-472C0B9A23A1}"/>
              </a:ext>
            </a:extLst>
          </p:cNvPr>
          <p:cNvSpPr txBox="1"/>
          <p:nvPr/>
        </p:nvSpPr>
        <p:spPr>
          <a:xfrm>
            <a:off x="1561697" y="454222"/>
            <a:ext cx="2964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Figure 2I) Anti-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ι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5598F85-57A2-5048-A906-D9E9962693B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2237" t="52150" r="5833" b="-727"/>
          <a:stretch/>
        </p:blipFill>
        <p:spPr>
          <a:xfrm>
            <a:off x="1536638" y="3321910"/>
            <a:ext cx="3014134" cy="24976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22C7796-C906-D04C-B4CA-7568828E56A1}"/>
              </a:ext>
            </a:extLst>
          </p:cNvPr>
          <p:cNvSpPr txBox="1"/>
          <p:nvPr/>
        </p:nvSpPr>
        <p:spPr>
          <a:xfrm>
            <a:off x="2040995" y="3029481"/>
            <a:ext cx="2005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2J) Anti-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1A7A051-B3C3-AC46-A3D4-15471F400886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27228" t="1759" r="45730" b="48537"/>
          <a:stretch/>
        </p:blipFill>
        <p:spPr>
          <a:xfrm>
            <a:off x="2120838" y="6536267"/>
            <a:ext cx="1845734" cy="206586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B098A1F-44AD-7043-B658-051B836DDA2A}"/>
              </a:ext>
            </a:extLst>
          </p:cNvPr>
          <p:cNvSpPr txBox="1"/>
          <p:nvPr/>
        </p:nvSpPr>
        <p:spPr>
          <a:xfrm>
            <a:off x="1881015" y="6228490"/>
            <a:ext cx="2325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2K) Anti-Tot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11479A-539B-0149-B35C-6639D2F2181C}"/>
              </a:ext>
            </a:extLst>
          </p:cNvPr>
          <p:cNvSpPr txBox="1"/>
          <p:nvPr/>
        </p:nvSpPr>
        <p:spPr>
          <a:xfrm>
            <a:off x="196355" y="97919"/>
            <a:ext cx="2629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ource Western blots:</a:t>
            </a:r>
          </a:p>
        </p:txBody>
      </p:sp>
      <p:pic>
        <p:nvPicPr>
          <p:cNvPr id="3" name="Picture 2" descr="A picture containing rectangle, screenshot, black and white, art&#10;&#10;Description automatically generated">
            <a:extLst>
              <a:ext uri="{FF2B5EF4-FFF2-40B4-BE49-F238E27FC236}">
                <a16:creationId xmlns:a16="http://schemas.microsoft.com/office/drawing/2014/main" id="{FF58BE4C-E578-6446-9970-933C84DE07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11660" y="759680"/>
            <a:ext cx="3164885" cy="221541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28727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DDEFB2C-9857-B343-9F31-2C5AEFFC636B}"/>
              </a:ext>
            </a:extLst>
          </p:cNvPr>
          <p:cNvSpPr txBox="1"/>
          <p:nvPr/>
        </p:nvSpPr>
        <p:spPr>
          <a:xfrm>
            <a:off x="1327176" y="1011580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3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076C5C7-0C4F-C645-98E5-AD62637370F6}"/>
              </a:ext>
            </a:extLst>
          </p:cNvPr>
          <p:cNvSpPr txBox="1"/>
          <p:nvPr/>
        </p:nvSpPr>
        <p:spPr>
          <a:xfrm>
            <a:off x="1884540" y="1351180"/>
            <a:ext cx="2255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er473 AKT</a:t>
            </a:r>
          </a:p>
        </p:txBody>
      </p:sp>
      <p:pic>
        <p:nvPicPr>
          <p:cNvPr id="6" name="Picture 5" descr="A picture containing text, building, outdoor, white&#10;&#10;Description automatically generated">
            <a:extLst>
              <a:ext uri="{FF2B5EF4-FFF2-40B4-BE49-F238E27FC236}">
                <a16:creationId xmlns:a16="http://schemas.microsoft.com/office/drawing/2014/main" id="{F8EAA961-DEFC-1E4A-AB89-9595C4C4A9D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4785"/>
          <a:stretch/>
        </p:blipFill>
        <p:spPr>
          <a:xfrm>
            <a:off x="1425201" y="1690780"/>
            <a:ext cx="3174173" cy="31154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51197F4-63C7-0745-869E-71E77801DBFB}"/>
              </a:ext>
            </a:extLst>
          </p:cNvPr>
          <p:cNvSpPr txBox="1"/>
          <p:nvPr/>
        </p:nvSpPr>
        <p:spPr>
          <a:xfrm>
            <a:off x="2347007" y="5240230"/>
            <a:ext cx="13305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ti- total AKT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BB0E313-14B5-E542-B00E-341A7199356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44759"/>
          <a:stretch/>
        </p:blipFill>
        <p:spPr>
          <a:xfrm>
            <a:off x="1425200" y="5548007"/>
            <a:ext cx="3174173" cy="3114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20341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graph&#10;&#10;Description automatically generated with low confidence">
            <a:extLst>
              <a:ext uri="{FF2B5EF4-FFF2-40B4-BE49-F238E27FC236}">
                <a16:creationId xmlns:a16="http://schemas.microsoft.com/office/drawing/2014/main" id="{E253E1F7-BB50-314B-B0D2-CBB1D9679D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66" t="58618" r="-194" b="3"/>
          <a:stretch/>
        </p:blipFill>
        <p:spPr>
          <a:xfrm>
            <a:off x="343161" y="4886325"/>
            <a:ext cx="5888306" cy="27003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8E32EDD-1F5E-DF4C-8F06-D8ECA66E1D02}"/>
              </a:ext>
            </a:extLst>
          </p:cNvPr>
          <p:cNvSpPr txBox="1"/>
          <p:nvPr/>
        </p:nvSpPr>
        <p:spPr>
          <a:xfrm>
            <a:off x="1615902" y="4572000"/>
            <a:ext cx="33118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4A) Anti-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 and anti-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 act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 descr="A picture containing light&#10;&#10;Description automatically generated">
            <a:extLst>
              <a:ext uri="{FF2B5EF4-FFF2-40B4-BE49-F238E27FC236}">
                <a16:creationId xmlns:a16="http://schemas.microsoft.com/office/drawing/2014/main" id="{AFBA0246-25F6-9044-9D68-9D58B2D4C99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0371"/>
          <a:stretch/>
        </p:blipFill>
        <p:spPr>
          <a:xfrm>
            <a:off x="343161" y="1362481"/>
            <a:ext cx="5704915" cy="25120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0FC27EF-65D9-6E4D-8786-1B9F718EF008}"/>
              </a:ext>
            </a:extLst>
          </p:cNvPr>
          <p:cNvSpPr txBox="1"/>
          <p:nvPr/>
        </p:nvSpPr>
        <p:spPr>
          <a:xfrm>
            <a:off x="2172069" y="1047085"/>
            <a:ext cx="2047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4A) Anti-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ι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57648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cabinet&#10;&#10;Description automatically generated">
            <a:extLst>
              <a:ext uri="{FF2B5EF4-FFF2-40B4-BE49-F238E27FC236}">
                <a16:creationId xmlns:a16="http://schemas.microsoft.com/office/drawing/2014/main" id="{ECBCF0FF-803B-EE48-A2CA-AB858B485A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050" y="2589064"/>
            <a:ext cx="5706000" cy="39658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6F9B175-CCCB-1644-B72D-F22A6BDC7F00}"/>
              </a:ext>
            </a:extLst>
          </p:cNvPr>
          <p:cNvSpPr txBox="1"/>
          <p:nvPr/>
        </p:nvSpPr>
        <p:spPr>
          <a:xfrm>
            <a:off x="2199845" y="2323632"/>
            <a:ext cx="21064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5G) Anti-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GSDM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48277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F945AA7-E8D2-DB45-A2FC-D526E492F31F}"/>
              </a:ext>
            </a:extLst>
          </p:cNvPr>
          <p:cNvSpPr txBox="1"/>
          <p:nvPr/>
        </p:nvSpPr>
        <p:spPr>
          <a:xfrm>
            <a:off x="715618" y="516834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5)</a:t>
            </a:r>
          </a:p>
        </p:txBody>
      </p:sp>
      <p:pic>
        <p:nvPicPr>
          <p:cNvPr id="6" name="Picture 5" descr="A picture containing text, light&#10;&#10;Description automatically generated">
            <a:extLst>
              <a:ext uri="{FF2B5EF4-FFF2-40B4-BE49-F238E27FC236}">
                <a16:creationId xmlns:a16="http://schemas.microsoft.com/office/drawing/2014/main" id="{228151D7-CEB4-724B-B4D9-53116BCBE0E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076" t="-3543" r="-2196" b="-10711"/>
          <a:stretch/>
        </p:blipFill>
        <p:spPr>
          <a:xfrm>
            <a:off x="715618" y="1258956"/>
            <a:ext cx="5088835" cy="310100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1789BC0-16AC-A849-ABE0-C6753CDE2D23}"/>
              </a:ext>
            </a:extLst>
          </p:cNvPr>
          <p:cNvSpPr txBox="1"/>
          <p:nvPr/>
        </p:nvSpPr>
        <p:spPr>
          <a:xfrm>
            <a:off x="2564300" y="951179"/>
            <a:ext cx="1391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) Anti-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ι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 descr="A picture containing white, indoor, appliance&#10;&#10;Description automatically generated">
            <a:extLst>
              <a:ext uri="{FF2B5EF4-FFF2-40B4-BE49-F238E27FC236}">
                <a16:creationId xmlns:a16="http://schemas.microsoft.com/office/drawing/2014/main" id="{9B295BD2-EB00-7148-B92F-36118E0AB8E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3413" t="5078" r="-1507" b="47307"/>
          <a:stretch/>
        </p:blipFill>
        <p:spPr>
          <a:xfrm>
            <a:off x="715618" y="5409864"/>
            <a:ext cx="5088835" cy="323353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AE14172-2644-D24B-9A58-68700AB79AF6}"/>
              </a:ext>
            </a:extLst>
          </p:cNvPr>
          <p:cNvSpPr txBox="1"/>
          <p:nvPr/>
        </p:nvSpPr>
        <p:spPr>
          <a:xfrm>
            <a:off x="2569910" y="5102087"/>
            <a:ext cx="13802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) Anti-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99185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DB641D6-D079-3943-85E3-ED22652BA9A7}"/>
              </a:ext>
            </a:extLst>
          </p:cNvPr>
          <p:cNvSpPr txBox="1"/>
          <p:nvPr/>
        </p:nvSpPr>
        <p:spPr>
          <a:xfrm>
            <a:off x="439149" y="1074951"/>
            <a:ext cx="11192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12)</a:t>
            </a:r>
          </a:p>
        </p:txBody>
      </p:sp>
      <p:pic>
        <p:nvPicPr>
          <p:cNvPr id="6" name="Picture 5" descr="A picture containing text, white, black, old&#10;&#10;Description automatically generated">
            <a:extLst>
              <a:ext uri="{FF2B5EF4-FFF2-40B4-BE49-F238E27FC236}">
                <a16:creationId xmlns:a16="http://schemas.microsoft.com/office/drawing/2014/main" id="{9902FDAD-7814-7343-BE97-D9982B26CCD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84" t="10036" r="614" b="-1119"/>
          <a:stretch/>
        </p:blipFill>
        <p:spPr>
          <a:xfrm>
            <a:off x="439149" y="1789045"/>
            <a:ext cx="5979702" cy="38431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450B06C-E82B-CA42-8FF7-F81B595F4872}"/>
              </a:ext>
            </a:extLst>
          </p:cNvPr>
          <p:cNvSpPr txBox="1"/>
          <p:nvPr/>
        </p:nvSpPr>
        <p:spPr>
          <a:xfrm>
            <a:off x="2822905" y="1382728"/>
            <a:ext cx="12121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GSDM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6697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</TotalTime>
  <Words>72</Words>
  <Application>Microsoft Macintosh PowerPoint</Application>
  <PresentationFormat>Letter Paper (8.5x11 in)</PresentationFormat>
  <Paragraphs>17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ghan Riddell</dc:creator>
  <cp:lastModifiedBy>Meghan Riddell</cp:lastModifiedBy>
  <cp:revision>10</cp:revision>
  <dcterms:created xsi:type="dcterms:W3CDTF">2022-05-19T20:32:41Z</dcterms:created>
  <dcterms:modified xsi:type="dcterms:W3CDTF">2023-06-13T20:58:15Z</dcterms:modified>
</cp:coreProperties>
</file>